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8" d="100"/>
          <a:sy n="78" d="100"/>
        </p:scale>
        <p:origin x="114" y="40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FCA159-B4CD-4214-83E2-0C4D86C94805}" type="datetimeFigureOut">
              <a:rPr lang="en-GB" smtClean="0"/>
              <a:t>10/05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EEB86F-CA9E-44BD-9727-BB2329914E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416312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FCA159-B4CD-4214-83E2-0C4D86C94805}" type="datetimeFigureOut">
              <a:rPr lang="en-GB" smtClean="0"/>
              <a:t>10/05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EEB86F-CA9E-44BD-9727-BB2329914E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707516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FCA159-B4CD-4214-83E2-0C4D86C94805}" type="datetimeFigureOut">
              <a:rPr lang="en-GB" smtClean="0"/>
              <a:t>10/05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EEB86F-CA9E-44BD-9727-BB2329914E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529420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FCA159-B4CD-4214-83E2-0C4D86C94805}" type="datetimeFigureOut">
              <a:rPr lang="en-GB" smtClean="0"/>
              <a:t>10/05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EEB86F-CA9E-44BD-9727-BB2329914E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18602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FCA159-B4CD-4214-83E2-0C4D86C94805}" type="datetimeFigureOut">
              <a:rPr lang="en-GB" smtClean="0"/>
              <a:t>10/05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EEB86F-CA9E-44BD-9727-BB2329914E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734117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FCA159-B4CD-4214-83E2-0C4D86C94805}" type="datetimeFigureOut">
              <a:rPr lang="en-GB" smtClean="0"/>
              <a:t>10/05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EEB86F-CA9E-44BD-9727-BB2329914E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240810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FCA159-B4CD-4214-83E2-0C4D86C94805}" type="datetimeFigureOut">
              <a:rPr lang="en-GB" smtClean="0"/>
              <a:t>10/05/202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EEB86F-CA9E-44BD-9727-BB2329914E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538817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FCA159-B4CD-4214-83E2-0C4D86C94805}" type="datetimeFigureOut">
              <a:rPr lang="en-GB" smtClean="0"/>
              <a:t>10/05/20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EEB86F-CA9E-44BD-9727-BB2329914E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873857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FCA159-B4CD-4214-83E2-0C4D86C94805}" type="datetimeFigureOut">
              <a:rPr lang="en-GB" smtClean="0"/>
              <a:t>10/05/202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EEB86F-CA9E-44BD-9727-BB2329914E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629224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FCA159-B4CD-4214-83E2-0C4D86C94805}" type="datetimeFigureOut">
              <a:rPr lang="en-GB" smtClean="0"/>
              <a:t>10/05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EEB86F-CA9E-44BD-9727-BB2329914E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959242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FCA159-B4CD-4214-83E2-0C4D86C94805}" type="datetimeFigureOut">
              <a:rPr lang="en-GB" smtClean="0"/>
              <a:t>10/05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EEB86F-CA9E-44BD-9727-BB2329914E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767405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FCA159-B4CD-4214-83E2-0C4D86C94805}" type="datetimeFigureOut">
              <a:rPr lang="en-GB" smtClean="0"/>
              <a:t>10/05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EEB86F-CA9E-44BD-9727-BB2329914E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174717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1973317" y="598643"/>
            <a:ext cx="3095626" cy="6143623"/>
            <a:chOff x="3886200" y="234043"/>
            <a:chExt cx="3095626" cy="6143623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886200" y="234043"/>
              <a:ext cx="3048000" cy="6096000"/>
            </a:xfrm>
            <a:prstGeom prst="rect">
              <a:avLst/>
            </a:prstGeom>
          </p:spPr>
        </p:pic>
        <p:sp>
          <p:nvSpPr>
            <p:cNvPr id="5" name="TextBox 4"/>
            <p:cNvSpPr txBox="1"/>
            <p:nvPr/>
          </p:nvSpPr>
          <p:spPr>
            <a:xfrm>
              <a:off x="4348841" y="348343"/>
              <a:ext cx="13716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4.35</a:t>
              </a:r>
              <a:r>
                <a:rPr lang="zh-CN" altLang="en-US" sz="1200" dirty="0"/>
                <a:t> </a:t>
              </a:r>
              <a:r>
                <a:rPr lang="en-GB" altLang="zh-CN" sz="1200" dirty="0"/>
                <a:t>(</a:t>
              </a:r>
              <a:r>
                <a:rPr lang="en-US" altLang="zh-CN" sz="1200" dirty="0"/>
                <a:t>2.74-6.03</a:t>
              </a:r>
              <a:r>
                <a:rPr lang="zh-CN" altLang="en-US" sz="1200" dirty="0"/>
                <a:t>）</a:t>
              </a:r>
              <a:endParaRPr lang="en-GB" sz="1200" dirty="0"/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5486402" y="348343"/>
              <a:ext cx="13716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4.99</a:t>
              </a:r>
              <a:r>
                <a:rPr lang="zh-CN" altLang="en-US" sz="1200" dirty="0"/>
                <a:t> </a:t>
              </a:r>
              <a:r>
                <a:rPr lang="en-GB" altLang="zh-CN" sz="1200" dirty="0"/>
                <a:t>(</a:t>
              </a:r>
              <a:r>
                <a:rPr lang="en-US" altLang="zh-CN" sz="1200" dirty="0"/>
                <a:t>3.10-6.88</a:t>
              </a:r>
              <a:r>
                <a:rPr lang="zh-CN" altLang="en-US" sz="1200" dirty="0"/>
                <a:t>）</a:t>
              </a:r>
              <a:endParaRPr lang="en-GB" sz="1200" dirty="0"/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72312E50-05CB-4CA0-9E4F-35EEBB235E7A}"/>
                </a:ext>
              </a:extLst>
            </p:cNvPr>
            <p:cNvSpPr txBox="1"/>
            <p:nvPr/>
          </p:nvSpPr>
          <p:spPr>
            <a:xfrm>
              <a:off x="5411529" y="5900612"/>
              <a:ext cx="1570297" cy="4770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at least one I allele</a:t>
              </a:r>
            </a:p>
            <a:p>
              <a:endParaRPr lang="en-GB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" name="Rectangle 1"/>
            <p:cNvSpPr/>
            <p:nvPr/>
          </p:nvSpPr>
          <p:spPr>
            <a:xfrm>
              <a:off x="5053691" y="6040649"/>
              <a:ext cx="356509" cy="28939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8CB15D97-2258-452E-8B95-9EB394EBA303}"/>
                </a:ext>
              </a:extLst>
            </p:cNvPr>
            <p:cNvSpPr txBox="1"/>
            <p:nvPr/>
          </p:nvSpPr>
          <p:spPr>
            <a:xfrm>
              <a:off x="4817352" y="5900317"/>
              <a:ext cx="479222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D/D</a:t>
              </a:r>
              <a:endParaRPr lang="en-GB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51955CD9-8DCA-48CF-8430-9647575ABAAC}"/>
                </a:ext>
              </a:extLst>
            </p:cNvPr>
            <p:cNvSpPr txBox="1"/>
            <p:nvPr/>
          </p:nvSpPr>
          <p:spPr>
            <a:xfrm rot="16200000">
              <a:off x="2762327" y="2851215"/>
              <a:ext cx="2478578" cy="2308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EPA/ALA ratio in RBC membranes at visit 1</a:t>
              </a:r>
              <a:endParaRPr lang="en-GB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0" name="TextBox 9"/>
          <p:cNvSpPr txBox="1"/>
          <p:nvPr/>
        </p:nvSpPr>
        <p:spPr>
          <a:xfrm>
            <a:off x="5906814" y="1478697"/>
            <a:ext cx="5475889" cy="42473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Supplementary Figure 1. Comparison of the eicosapentaenoic acid (EPA)/alpha-</a:t>
            </a:r>
            <a:r>
              <a:rPr lang="en-GB" b="1" dirty="0" err="1"/>
              <a:t>linolenic</a:t>
            </a:r>
            <a:r>
              <a:rPr lang="en-GB" b="1" dirty="0"/>
              <a:t> acid (ALA) ratio in red blood cell membranes according to </a:t>
            </a:r>
            <a:r>
              <a:rPr lang="en-GB" b="1" i="1" dirty="0"/>
              <a:t>FADS</a:t>
            </a:r>
            <a:r>
              <a:rPr lang="en-GB" b="1" dirty="0"/>
              <a:t> </a:t>
            </a:r>
            <a:r>
              <a:rPr lang="en-GB" b="1" dirty="0" err="1"/>
              <a:t>Indel</a:t>
            </a:r>
            <a:r>
              <a:rPr lang="en-GB" b="1" dirty="0"/>
              <a:t> genotype.</a:t>
            </a:r>
            <a:r>
              <a:rPr lang="en-GB" dirty="0"/>
              <a:t> Violin plot, with embedded box and whisker plot and individual data points, of baseline (seAFOod trial visit 1) red blood cell (RBC) membrane EPA/ALA ratio values in 584 trial participants with a </a:t>
            </a:r>
            <a:r>
              <a:rPr lang="en-GB" i="1" dirty="0"/>
              <a:t>FADS</a:t>
            </a:r>
            <a:r>
              <a:rPr lang="en-GB" dirty="0"/>
              <a:t> </a:t>
            </a:r>
            <a:r>
              <a:rPr lang="en-GB" dirty="0" err="1"/>
              <a:t>Indel</a:t>
            </a:r>
            <a:r>
              <a:rPr lang="en-GB" dirty="0"/>
              <a:t> genotype and available RBC highly unsaturated fatty acid data [6]. The EPA/ALA ratio was calculated using % levels of EPA and ALA of total fatty acids in RBCs measured by liquid chromatography-mass spectrometry [17,23]. P=0.0075 for the difference between I carriers and D/D homozygotes (Wilcoxon rank-sum test). The median value and inter-quartile range for the </a:t>
            </a:r>
            <a:r>
              <a:rPr lang="en-GB" i="1" dirty="0"/>
              <a:t>FADS</a:t>
            </a:r>
            <a:r>
              <a:rPr lang="en-GB" dirty="0"/>
              <a:t> Indel genotype groups is noted above the respective plot.  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9071993-0DE2-B092-E13C-1B6BD05A1B2B}"/>
              </a:ext>
            </a:extLst>
          </p:cNvPr>
          <p:cNvSpPr txBox="1"/>
          <p:nvPr/>
        </p:nvSpPr>
        <p:spPr>
          <a:xfrm>
            <a:off x="222422" y="12353"/>
            <a:ext cx="1173891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Supplementary material:</a:t>
            </a:r>
            <a:r>
              <a:rPr lang="en-GB" sz="1400" b="1" i="1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Fatty acid desaturase</a:t>
            </a:r>
            <a:r>
              <a:rPr lang="en-GB" sz="1400" b="1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insertion-deletion polymorphism rs66698963 predicts colorectal polyp prevention by the </a:t>
            </a:r>
            <a:r>
              <a:rPr lang="en-GB" sz="1400" b="1" i="1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n</a:t>
            </a:r>
            <a:r>
              <a:rPr lang="en-GB" sz="1400" b="1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-3 fatty acid eicosapentaenoic acid: A secondary analysis of the seAFOod polyp prevention trial. Ge Sun, et al.</a:t>
            </a:r>
            <a:endParaRPr lang="en-GB" sz="1400" b="1" dirty="0">
              <a:effectLst/>
              <a:latin typeface="Calibri" panose="020F0502020204030204" pitchFamily="34" charset="0"/>
              <a:ea typeface="DengXian" panose="02010600030101010101" pitchFamily="2" charset="-12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603898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1</TotalTime>
  <Words>212</Words>
  <Application>Microsoft Office PowerPoint</Application>
  <PresentationFormat>Widescreen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of Leed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e Sun</dc:creator>
  <cp:lastModifiedBy>Mark Hull</cp:lastModifiedBy>
  <cp:revision>6</cp:revision>
  <dcterms:created xsi:type="dcterms:W3CDTF">2024-04-26T15:22:31Z</dcterms:created>
  <dcterms:modified xsi:type="dcterms:W3CDTF">2024-05-10T15:07:14Z</dcterms:modified>
</cp:coreProperties>
</file>